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0" r:id="rId3"/>
    <p:sldId id="272" r:id="rId4"/>
    <p:sldId id="271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6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AF2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7" autoAdjust="0"/>
    <p:restoredTop sz="94660"/>
  </p:normalViewPr>
  <p:slideViewPr>
    <p:cSldViewPr snapToGrid="0" showGuides="1">
      <p:cViewPr varScale="1">
        <p:scale>
          <a:sx n="69" d="100"/>
          <a:sy n="69" d="100"/>
        </p:scale>
        <p:origin x="2074" y="67"/>
      </p:cViewPr>
      <p:guideLst>
        <p:guide orient="horz" pos="566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2536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058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1259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860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0784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9281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9689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8112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9805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98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123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136F1-5E82-46FE-84EF-4EE8A0C602BD}" type="datetimeFigureOut">
              <a:rPr lang="en-GB" smtClean="0"/>
              <a:t>13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0423-806C-4951-986D-7DF3444D87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2750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"/><Relationship Id="rId3" Type="http://schemas.openxmlformats.org/officeDocument/2006/relationships/image" Target="../media/image14.jpeg"/><Relationship Id="rId7" Type="http://schemas.openxmlformats.org/officeDocument/2006/relationships/image" Target="../media/image17.tif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microsoft.com/office/2007/relationships/hdphoto" Target="../media/hdphoto1.wdp"/><Relationship Id="rId4" Type="http://schemas.openxmlformats.org/officeDocument/2006/relationships/image" Target="../media/image15.png"/><Relationship Id="rId9" Type="http://schemas.openxmlformats.org/officeDocument/2006/relationships/image" Target="../media/image19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microsoft.com/office/2007/relationships/hdphoto" Target="../media/hdphoto2.wdp"/><Relationship Id="rId7" Type="http://schemas.openxmlformats.org/officeDocument/2006/relationships/image" Target="../media/image24.jpe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9803" y="161319"/>
            <a:ext cx="2336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Figure 5 A  (Left panel)</a:t>
            </a:r>
            <a:endParaRPr lang="en-GB" b="1" dirty="0">
              <a:solidFill>
                <a:srgbClr val="0070C0"/>
              </a:solidFill>
            </a:endParaRPr>
          </a:p>
        </p:txBody>
      </p:sp>
      <p:pic>
        <p:nvPicPr>
          <p:cNvPr id="8" name="Picture 7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26" t="27869" r="41835" b="28797"/>
          <a:stretch/>
        </p:blipFill>
        <p:spPr>
          <a:xfrm>
            <a:off x="3820456" y="2119712"/>
            <a:ext cx="1800000" cy="2222944"/>
          </a:xfrm>
          <a:prstGeom prst="rect">
            <a:avLst/>
          </a:prstGeom>
        </p:spPr>
      </p:pic>
      <p:pic>
        <p:nvPicPr>
          <p:cNvPr id="9" name="Picture 8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02" t="27167" r="52426" b="29528"/>
          <a:stretch/>
        </p:blipFill>
        <p:spPr>
          <a:xfrm>
            <a:off x="1358040" y="4377573"/>
            <a:ext cx="1800000" cy="2160000"/>
          </a:xfrm>
          <a:prstGeom prst="rect">
            <a:avLst/>
          </a:prstGeom>
        </p:spPr>
      </p:pic>
      <p:pic>
        <p:nvPicPr>
          <p:cNvPr id="10" name="Picture 9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9" t="29981" r="48903" b="27214"/>
          <a:stretch/>
        </p:blipFill>
        <p:spPr>
          <a:xfrm>
            <a:off x="3820456" y="4390222"/>
            <a:ext cx="1800000" cy="2160000"/>
          </a:xfrm>
          <a:prstGeom prst="rect">
            <a:avLst/>
          </a:prstGeom>
        </p:spPr>
      </p:pic>
      <p:pic>
        <p:nvPicPr>
          <p:cNvPr id="11" name="Picture 10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06" t="27271" r="47180" b="29220"/>
          <a:stretch/>
        </p:blipFill>
        <p:spPr>
          <a:xfrm>
            <a:off x="1358040" y="2170007"/>
            <a:ext cx="1800000" cy="2160000"/>
          </a:xfrm>
          <a:prstGeom prst="rect">
            <a:avLst/>
          </a:prstGeom>
        </p:spPr>
      </p:pic>
      <p:pic>
        <p:nvPicPr>
          <p:cNvPr id="12" name="Picture 11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20" t="35157" r="33236" b="24196"/>
          <a:stretch/>
        </p:blipFill>
        <p:spPr>
          <a:xfrm>
            <a:off x="1358040" y="6605148"/>
            <a:ext cx="1800000" cy="2076144"/>
          </a:xfrm>
          <a:prstGeom prst="rect">
            <a:avLst/>
          </a:prstGeom>
        </p:spPr>
      </p:pic>
      <p:pic>
        <p:nvPicPr>
          <p:cNvPr id="13" name="Picture 12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57" t="30738" r="45478" b="27009"/>
          <a:stretch/>
        </p:blipFill>
        <p:spPr>
          <a:xfrm>
            <a:off x="3821343" y="6617797"/>
            <a:ext cx="1800000" cy="216000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1689741" y="2370496"/>
            <a:ext cx="1440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3978522" y="2382261"/>
            <a:ext cx="1584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1652919" y="4777267"/>
            <a:ext cx="1440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3982644" y="4789032"/>
            <a:ext cx="1584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/>
          <p:cNvSpPr/>
          <p:nvPr/>
        </p:nvSpPr>
        <p:spPr>
          <a:xfrm>
            <a:off x="1689741" y="8192366"/>
            <a:ext cx="1440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/>
          <p:cNvSpPr/>
          <p:nvPr/>
        </p:nvSpPr>
        <p:spPr>
          <a:xfrm>
            <a:off x="3978522" y="8193245"/>
            <a:ext cx="1584000" cy="46605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TextBox 23"/>
          <p:cNvSpPr txBox="1"/>
          <p:nvPr/>
        </p:nvSpPr>
        <p:spPr>
          <a:xfrm>
            <a:off x="1859802" y="1058573"/>
            <a:ext cx="7813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1350486" y="1370919"/>
            <a:ext cx="180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306292" y="1071222"/>
            <a:ext cx="928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P: Myc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3820456" y="1396672"/>
            <a:ext cx="180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29028" y="2369612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I3FL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07446" y="8217381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MX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29028" y="4800702"/>
            <a:ext cx="803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30809" y="4668100"/>
            <a:ext cx="420308" cy="1277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215514" y="6863017"/>
            <a:ext cx="420371" cy="19543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173596" y="2440525"/>
            <a:ext cx="477521" cy="1277273"/>
            <a:chOff x="3140143" y="2440525"/>
            <a:chExt cx="477521" cy="1277273"/>
          </a:xfrm>
        </p:grpSpPr>
        <p:sp>
          <p:nvSpPr>
            <p:cNvPr id="2" name="TextBox 1"/>
            <p:cNvSpPr txBox="1"/>
            <p:nvPr/>
          </p:nvSpPr>
          <p:spPr>
            <a:xfrm>
              <a:off x="3170909" y="2440525"/>
              <a:ext cx="446755" cy="1277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</a:p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GB" sz="11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3140143" y="2547256"/>
              <a:ext cx="105071" cy="1066802"/>
              <a:chOff x="3140143" y="2547256"/>
              <a:chExt cx="105071" cy="1066802"/>
            </a:xfrm>
          </p:grpSpPr>
          <p:cxnSp>
            <p:nvCxnSpPr>
              <p:cNvPr id="4" name="Straight Connector 3"/>
              <p:cNvCxnSpPr/>
              <p:nvPr/>
            </p:nvCxnSpPr>
            <p:spPr>
              <a:xfrm>
                <a:off x="3140143" y="361405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3140143" y="3352794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3140143" y="312419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3140143" y="287382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3140143" y="2743204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3140143" y="2547256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8" name="Group 47"/>
          <p:cNvGrpSpPr/>
          <p:nvPr/>
        </p:nvGrpSpPr>
        <p:grpSpPr>
          <a:xfrm>
            <a:off x="3161179" y="4773335"/>
            <a:ext cx="105071" cy="1066802"/>
            <a:chOff x="3140143" y="2547256"/>
            <a:chExt cx="105071" cy="1066802"/>
          </a:xfrm>
        </p:grpSpPr>
        <p:cxnSp>
          <p:nvCxnSpPr>
            <p:cNvPr id="49" name="Straight Connector 48"/>
            <p:cNvCxnSpPr/>
            <p:nvPr/>
          </p:nvCxnSpPr>
          <p:spPr>
            <a:xfrm>
              <a:off x="3140143" y="361405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3140143" y="335279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3140143" y="312419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3140143" y="287382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/>
          <p:cNvGrpSpPr/>
          <p:nvPr/>
        </p:nvGrpSpPr>
        <p:grpSpPr>
          <a:xfrm>
            <a:off x="3152107" y="6968252"/>
            <a:ext cx="105071" cy="1632864"/>
            <a:chOff x="3152107" y="6968252"/>
            <a:chExt cx="105071" cy="1632864"/>
          </a:xfrm>
        </p:grpSpPr>
        <p:grpSp>
          <p:nvGrpSpPr>
            <p:cNvPr id="55" name="Group 54"/>
            <p:cNvGrpSpPr/>
            <p:nvPr/>
          </p:nvGrpSpPr>
          <p:grpSpPr>
            <a:xfrm>
              <a:off x="3152107" y="6968252"/>
              <a:ext cx="105071" cy="1066802"/>
              <a:chOff x="3140143" y="2547256"/>
              <a:chExt cx="105071" cy="1066802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>
                <a:off x="3140143" y="361405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3140143" y="3352794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3140143" y="312419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3140143" y="2873828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3140143" y="2743204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3140143" y="2547256"/>
                <a:ext cx="105071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2" name="Straight Connector 61"/>
            <p:cNvCxnSpPr/>
            <p:nvPr/>
          </p:nvCxnSpPr>
          <p:spPr>
            <a:xfrm>
              <a:off x="3152107" y="829631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3152107" y="860111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TextBox 63"/>
          <p:cNvSpPr txBox="1"/>
          <p:nvPr/>
        </p:nvSpPr>
        <p:spPr>
          <a:xfrm>
            <a:off x="652132" y="1561076"/>
            <a:ext cx="2605200" cy="60016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GLI3FL       +             -             +</a:t>
            </a: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-WDR11       -             +             +</a:t>
            </a: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HA-EMX1       +             +             +  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158040" y="1512762"/>
            <a:ext cx="2605200" cy="60016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GLI3FL       +             -             +</a:t>
            </a: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-WDR11       -             +             +</a:t>
            </a: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HA-EMX1       +             +             +  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1882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98"/>
          <a:stretch/>
        </p:blipFill>
        <p:spPr>
          <a:xfrm>
            <a:off x="3478099" y="3937919"/>
            <a:ext cx="2880000" cy="1022873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0099" y="2867626"/>
            <a:ext cx="2880000" cy="1004787"/>
          </a:xfrm>
          <a:prstGeom prst="rect">
            <a:avLst/>
          </a:prstGeom>
        </p:spPr>
      </p:pic>
      <p:pic>
        <p:nvPicPr>
          <p:cNvPr id="50" name="Picture 49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0159" y="1868207"/>
            <a:ext cx="2880000" cy="934872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780" y="3893208"/>
            <a:ext cx="3116327" cy="1053517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" b="7380"/>
          <a:stretch/>
        </p:blipFill>
        <p:spPr>
          <a:xfrm>
            <a:off x="167268" y="2881210"/>
            <a:ext cx="3247855" cy="977618"/>
          </a:xfrm>
          <a:prstGeom prst="rect">
            <a:avLst/>
          </a:prstGeom>
        </p:spPr>
      </p:pic>
      <p:pic>
        <p:nvPicPr>
          <p:cNvPr id="47" name="Picture 46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670" y="1893070"/>
            <a:ext cx="2880000" cy="926592"/>
          </a:xfrm>
          <a:prstGeom prst="rect">
            <a:avLst/>
          </a:prstGeom>
        </p:spPr>
      </p:pic>
      <p:sp>
        <p:nvSpPr>
          <p:cNvPr id="36" name="Rectangle 35"/>
          <p:cNvSpPr/>
          <p:nvPr/>
        </p:nvSpPr>
        <p:spPr>
          <a:xfrm>
            <a:off x="551107" y="2288123"/>
            <a:ext cx="284400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501806" y="3225262"/>
            <a:ext cx="287349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481915" y="4548556"/>
            <a:ext cx="284400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/>
          <p:cNvSpPr/>
          <p:nvPr/>
        </p:nvSpPr>
        <p:spPr>
          <a:xfrm>
            <a:off x="3518276" y="4548415"/>
            <a:ext cx="284400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/>
          <p:cNvSpPr/>
          <p:nvPr/>
        </p:nvSpPr>
        <p:spPr>
          <a:xfrm>
            <a:off x="3478099" y="3225262"/>
            <a:ext cx="284400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3478099" y="2299017"/>
            <a:ext cx="2844000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3" name="Straight Connector 52"/>
          <p:cNvCxnSpPr/>
          <p:nvPr/>
        </p:nvCxnSpPr>
        <p:spPr>
          <a:xfrm>
            <a:off x="564375" y="1322087"/>
            <a:ext cx="2810921" cy="1431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595691" y="999291"/>
            <a:ext cx="7813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3665490" y="1329242"/>
            <a:ext cx="2759324" cy="2026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4579253" y="1013602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P: Myc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81708" y="1846889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I3R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31720" y="2858275"/>
            <a:ext cx="710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64375" y="3858828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MX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6393192" y="3872413"/>
            <a:ext cx="341825" cy="1031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grpSp>
        <p:nvGrpSpPr>
          <p:cNvPr id="113" name="Group 112"/>
          <p:cNvGrpSpPr/>
          <p:nvPr/>
        </p:nvGrpSpPr>
        <p:grpSpPr>
          <a:xfrm>
            <a:off x="6331707" y="2036963"/>
            <a:ext cx="105071" cy="576942"/>
            <a:chOff x="3140143" y="2547256"/>
            <a:chExt cx="105071" cy="576942"/>
          </a:xfrm>
        </p:grpSpPr>
        <p:cxnSp>
          <p:nvCxnSpPr>
            <p:cNvPr id="118" name="Straight Connector 117"/>
            <p:cNvCxnSpPr/>
            <p:nvPr/>
          </p:nvCxnSpPr>
          <p:spPr>
            <a:xfrm>
              <a:off x="3140143" y="312419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TextBox 121"/>
          <p:cNvSpPr txBox="1"/>
          <p:nvPr/>
        </p:nvSpPr>
        <p:spPr>
          <a:xfrm>
            <a:off x="6331707" y="2836357"/>
            <a:ext cx="446755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endParaRPr lang="en-GB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endParaRPr lang="en-GB" sz="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5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6322099" y="1855770"/>
            <a:ext cx="44675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GB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endParaRPr lang="en-GB" sz="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5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6331707" y="2951361"/>
            <a:ext cx="105071" cy="827326"/>
            <a:chOff x="6331707" y="6229813"/>
            <a:chExt cx="105071" cy="827326"/>
          </a:xfrm>
        </p:grpSpPr>
        <p:cxnSp>
          <p:nvCxnSpPr>
            <p:cNvPr id="124" name="Straight Connector 123"/>
            <p:cNvCxnSpPr/>
            <p:nvPr/>
          </p:nvCxnSpPr>
          <p:spPr>
            <a:xfrm>
              <a:off x="6331707" y="6491077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>
              <a:off x="6331707" y="6229813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/>
            <p:cNvCxnSpPr/>
            <p:nvPr/>
          </p:nvCxnSpPr>
          <p:spPr>
            <a:xfrm>
              <a:off x="6331707" y="6752337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/>
            <p:cNvCxnSpPr/>
            <p:nvPr/>
          </p:nvCxnSpPr>
          <p:spPr>
            <a:xfrm>
              <a:off x="6331707" y="7057139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8" name="Group 127"/>
          <p:cNvGrpSpPr/>
          <p:nvPr/>
        </p:nvGrpSpPr>
        <p:grpSpPr>
          <a:xfrm>
            <a:off x="6343010" y="3971155"/>
            <a:ext cx="105071" cy="783759"/>
            <a:chOff x="3140143" y="2547256"/>
            <a:chExt cx="105071" cy="783759"/>
          </a:xfrm>
        </p:grpSpPr>
        <p:cxnSp>
          <p:nvCxnSpPr>
            <p:cNvPr id="129" name="Straight Connector 128"/>
            <p:cNvCxnSpPr/>
            <p:nvPr/>
          </p:nvCxnSpPr>
          <p:spPr>
            <a:xfrm>
              <a:off x="3140143" y="3331015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3140143" y="296092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TextBox 91"/>
          <p:cNvSpPr txBox="1"/>
          <p:nvPr/>
        </p:nvSpPr>
        <p:spPr>
          <a:xfrm>
            <a:off x="167268" y="80238"/>
            <a:ext cx="2467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Figure 5 A  (Right panel)</a:t>
            </a:r>
            <a:endParaRPr lang="en-GB" b="1" dirty="0">
              <a:solidFill>
                <a:srgbClr val="0070C0"/>
              </a:solidFill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-230790" y="1405783"/>
            <a:ext cx="37455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I3R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-          +            +             +               +            +            +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WDR11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+          -            +             +              MT         M2         M4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A-EMX1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+         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    +             -                +            +            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665490" y="1389148"/>
            <a:ext cx="37455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-          +            +             +               +            +            +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  -            +             +              MT         M2         M4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 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           +             -                +            +            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6390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65" t="36602" r="49524" b="46667"/>
          <a:stretch/>
        </p:blipFill>
        <p:spPr>
          <a:xfrm>
            <a:off x="1895021" y="1199564"/>
            <a:ext cx="1440000" cy="1393371"/>
          </a:xfrm>
          <a:prstGeom prst="rect">
            <a:avLst/>
          </a:prstGeom>
        </p:spPr>
      </p:pic>
      <p:pic>
        <p:nvPicPr>
          <p:cNvPr id="51" name="Picture 50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92" t="35238" r="50635" b="43809"/>
          <a:stretch/>
        </p:blipFill>
        <p:spPr>
          <a:xfrm>
            <a:off x="3711266" y="1199563"/>
            <a:ext cx="1440000" cy="1393371"/>
          </a:xfrm>
          <a:prstGeom prst="rect">
            <a:avLst/>
          </a:prstGeom>
        </p:spPr>
      </p:pic>
      <p:pic>
        <p:nvPicPr>
          <p:cNvPr id="52" name="Picture 51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21" t="32539" r="51428" b="48059"/>
          <a:stretch/>
        </p:blipFill>
        <p:spPr>
          <a:xfrm>
            <a:off x="3711266" y="2686423"/>
            <a:ext cx="1440000" cy="1711658"/>
          </a:xfrm>
          <a:prstGeom prst="rect">
            <a:avLst/>
          </a:prstGeom>
        </p:spPr>
      </p:pic>
      <p:pic>
        <p:nvPicPr>
          <p:cNvPr id="53" name="Picture 52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895022" y="2693106"/>
            <a:ext cx="1440000" cy="1704975"/>
          </a:xfrm>
          <a:prstGeom prst="rect">
            <a:avLst/>
          </a:prstGeom>
        </p:spPr>
      </p:pic>
      <p:sp>
        <p:nvSpPr>
          <p:cNvPr id="54" name="Rectangle 53"/>
          <p:cNvSpPr/>
          <p:nvPr/>
        </p:nvSpPr>
        <p:spPr>
          <a:xfrm>
            <a:off x="2040744" y="1982001"/>
            <a:ext cx="1179172" cy="434985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Rectangle 54"/>
          <p:cNvSpPr/>
          <p:nvPr/>
        </p:nvSpPr>
        <p:spPr>
          <a:xfrm>
            <a:off x="3874961" y="1982001"/>
            <a:ext cx="1179172" cy="434985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/>
          <p:cNvSpPr/>
          <p:nvPr/>
        </p:nvSpPr>
        <p:spPr>
          <a:xfrm>
            <a:off x="2040744" y="3938777"/>
            <a:ext cx="1179172" cy="434985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/>
          <p:cNvSpPr/>
          <p:nvPr/>
        </p:nvSpPr>
        <p:spPr>
          <a:xfrm>
            <a:off x="3808399" y="3984570"/>
            <a:ext cx="1179172" cy="434985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9" name="Picture 68"/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889"/>
          <a:stretch/>
        </p:blipFill>
        <p:spPr>
          <a:xfrm>
            <a:off x="1930233" y="7346907"/>
            <a:ext cx="1440000" cy="1080000"/>
          </a:xfrm>
          <a:prstGeom prst="rect">
            <a:avLst/>
          </a:prstGeom>
        </p:spPr>
      </p:pic>
      <p:pic>
        <p:nvPicPr>
          <p:cNvPr id="70" name="Picture 69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932" y="6087526"/>
            <a:ext cx="1440000" cy="1222931"/>
          </a:xfrm>
          <a:prstGeom prst="rect">
            <a:avLst/>
          </a:prstGeom>
        </p:spPr>
      </p:pic>
      <p:pic>
        <p:nvPicPr>
          <p:cNvPr id="71" name="Picture 70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71" t="13934" r="45822" b="50157"/>
          <a:stretch/>
        </p:blipFill>
        <p:spPr>
          <a:xfrm>
            <a:off x="3769385" y="6087525"/>
            <a:ext cx="1440000" cy="2340379"/>
          </a:xfrm>
          <a:prstGeom prst="rect">
            <a:avLst/>
          </a:prstGeom>
        </p:spPr>
      </p:pic>
      <p:sp>
        <p:nvSpPr>
          <p:cNvPr id="74" name="Rectangle 73"/>
          <p:cNvSpPr/>
          <p:nvPr/>
        </p:nvSpPr>
        <p:spPr>
          <a:xfrm>
            <a:off x="2082974" y="6166181"/>
            <a:ext cx="1245103" cy="432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TextBox 75"/>
          <p:cNvSpPr txBox="1"/>
          <p:nvPr/>
        </p:nvSpPr>
        <p:spPr>
          <a:xfrm>
            <a:off x="5227463" y="6349775"/>
            <a:ext cx="975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2228552" y="5293357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EK293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9014132">
            <a:off x="2110483" y="5753165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9014132">
            <a:off x="2740959" y="5755613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080126" y="6201762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GLI3F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080126" y="7066445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GLI3R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080126" y="7886907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080126" y="398457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GLI3R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080126" y="203533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EMX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Connector 85"/>
          <p:cNvCxnSpPr/>
          <p:nvPr/>
        </p:nvCxnSpPr>
        <p:spPr>
          <a:xfrm>
            <a:off x="1865910" y="885967"/>
            <a:ext cx="144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2224316" y="560810"/>
            <a:ext cx="7813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3711266" y="887116"/>
            <a:ext cx="144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4045981" y="571557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P: Myc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9014132">
            <a:off x="2063278" y="1102148"/>
            <a:ext cx="7889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MEFs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9014132">
            <a:off x="2563948" y="1049525"/>
            <a:ext cx="8210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 -/-</a:t>
            </a:r>
          </a:p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EFs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9014132">
            <a:off x="3800177" y="1102150"/>
            <a:ext cx="7889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MEFs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9014132">
            <a:off x="4300847" y="1049527"/>
            <a:ext cx="8210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 -/-</a:t>
            </a:r>
          </a:p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EFs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996674" y="5290768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EK293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9014132">
            <a:off x="3946133" y="5753164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 rot="19014132">
            <a:off x="4526688" y="5765952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2060807" y="6883103"/>
            <a:ext cx="1245103" cy="432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ectangle 99"/>
          <p:cNvSpPr/>
          <p:nvPr/>
        </p:nvSpPr>
        <p:spPr>
          <a:xfrm>
            <a:off x="2093218" y="7890034"/>
            <a:ext cx="1245103" cy="432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Rectangle 100"/>
          <p:cNvSpPr/>
          <p:nvPr/>
        </p:nvSpPr>
        <p:spPr>
          <a:xfrm>
            <a:off x="3885227" y="6287107"/>
            <a:ext cx="1245103" cy="432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02" name="Straight Connector 101"/>
          <p:cNvCxnSpPr/>
          <p:nvPr/>
        </p:nvCxnSpPr>
        <p:spPr>
          <a:xfrm>
            <a:off x="1989000" y="5635558"/>
            <a:ext cx="144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3749721" y="5638290"/>
            <a:ext cx="144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346074" y="1358807"/>
            <a:ext cx="341825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3295892" y="1457549"/>
            <a:ext cx="105071" cy="859961"/>
            <a:chOff x="3140143" y="2547256"/>
            <a:chExt cx="105071" cy="859961"/>
          </a:xfrm>
        </p:grpSpPr>
        <p:cxnSp>
          <p:nvCxnSpPr>
            <p:cNvPr id="43" name="Straight Connector 42"/>
            <p:cNvCxnSpPr/>
            <p:nvPr/>
          </p:nvCxnSpPr>
          <p:spPr>
            <a:xfrm>
              <a:off x="3140143" y="3407217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3140143" y="296092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/>
          <p:cNvGrpSpPr/>
          <p:nvPr/>
        </p:nvGrpSpPr>
        <p:grpSpPr>
          <a:xfrm>
            <a:off x="3328077" y="3364429"/>
            <a:ext cx="105071" cy="576942"/>
            <a:chOff x="3140143" y="2547256"/>
            <a:chExt cx="105071" cy="576942"/>
          </a:xfrm>
        </p:grpSpPr>
        <p:cxnSp>
          <p:nvCxnSpPr>
            <p:cNvPr id="47" name="Straight Connector 46"/>
            <p:cNvCxnSpPr/>
            <p:nvPr/>
          </p:nvCxnSpPr>
          <p:spPr>
            <a:xfrm>
              <a:off x="3140143" y="312419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TextBox 58"/>
          <p:cNvSpPr txBox="1"/>
          <p:nvPr/>
        </p:nvSpPr>
        <p:spPr>
          <a:xfrm>
            <a:off x="3317049" y="3186816"/>
            <a:ext cx="44675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GB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endParaRPr lang="en-GB" sz="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r"/>
            <a:endParaRPr lang="en-GB" sz="5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3328074" y="4333259"/>
            <a:ext cx="105071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3400602" y="6158504"/>
            <a:ext cx="446755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Group 63"/>
          <p:cNvGrpSpPr/>
          <p:nvPr/>
        </p:nvGrpSpPr>
        <p:grpSpPr>
          <a:xfrm>
            <a:off x="3337474" y="6243655"/>
            <a:ext cx="105071" cy="979714"/>
            <a:chOff x="3140143" y="2547256"/>
            <a:chExt cx="105071" cy="979714"/>
          </a:xfrm>
        </p:grpSpPr>
        <p:cxnSp>
          <p:nvCxnSpPr>
            <p:cNvPr id="65" name="Straight Connector 64"/>
            <p:cNvCxnSpPr/>
            <p:nvPr/>
          </p:nvCxnSpPr>
          <p:spPr>
            <a:xfrm>
              <a:off x="3140143" y="3526970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3140143" y="3222162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3140143" y="287382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Group 76"/>
          <p:cNvGrpSpPr/>
          <p:nvPr/>
        </p:nvGrpSpPr>
        <p:grpSpPr>
          <a:xfrm>
            <a:off x="3346827" y="7615264"/>
            <a:ext cx="105071" cy="446313"/>
            <a:chOff x="3140143" y="2612572"/>
            <a:chExt cx="105071" cy="446313"/>
          </a:xfrm>
        </p:grpSpPr>
        <p:cxnSp>
          <p:nvCxnSpPr>
            <p:cNvPr id="104" name="Straight Connector 103"/>
            <p:cNvCxnSpPr/>
            <p:nvPr/>
          </p:nvCxnSpPr>
          <p:spPr>
            <a:xfrm>
              <a:off x="3140143" y="3058885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3140143" y="2612572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/>
          <p:cNvSpPr txBox="1"/>
          <p:nvPr/>
        </p:nvSpPr>
        <p:spPr>
          <a:xfrm>
            <a:off x="232036" y="206210"/>
            <a:ext cx="1118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Figure 5 C</a:t>
            </a:r>
            <a:endParaRPr lang="en-GB" b="1" dirty="0">
              <a:solidFill>
                <a:srgbClr val="0070C0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008171" y="1499472"/>
            <a:ext cx="21194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A-EMX1            +            +</a:t>
            </a:r>
          </a:p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-GLI3R         +             +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976485" y="1543195"/>
            <a:ext cx="22060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      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HA-EMX1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     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+            Myc-GLI3R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2027541" y="1524444"/>
            <a:ext cx="11917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3819174" y="1565332"/>
            <a:ext cx="11917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232036" y="4930590"/>
            <a:ext cx="2289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Figure 5 D (Left panel)</a:t>
            </a:r>
            <a:endParaRPr lang="en-GB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1184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766" t="44119" r="39649" b="37316"/>
          <a:stretch/>
        </p:blipFill>
        <p:spPr>
          <a:xfrm>
            <a:off x="3706236" y="1742086"/>
            <a:ext cx="2160000" cy="1753795"/>
          </a:xfrm>
          <a:prstGeom prst="rect">
            <a:avLst/>
          </a:prstGeom>
        </p:spPr>
      </p:pic>
      <p:pic>
        <p:nvPicPr>
          <p:cNvPr id="5" name="Picture 4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84" t="44196" r="39156" b="33705"/>
          <a:stretch/>
        </p:blipFill>
        <p:spPr>
          <a:xfrm>
            <a:off x="1163016" y="1728437"/>
            <a:ext cx="2160000" cy="1767443"/>
          </a:xfrm>
          <a:prstGeom prst="rect">
            <a:avLst/>
          </a:prstGeom>
        </p:spPr>
      </p:pic>
      <p:pic>
        <p:nvPicPr>
          <p:cNvPr id="6" name="Picture 5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84" t="34367" r="38140" b="38501"/>
          <a:stretch/>
        </p:blipFill>
        <p:spPr>
          <a:xfrm>
            <a:off x="1163016" y="3702457"/>
            <a:ext cx="2160000" cy="2160000"/>
          </a:xfrm>
          <a:prstGeom prst="rect">
            <a:avLst/>
          </a:prstGeom>
        </p:spPr>
      </p:pic>
      <p:pic>
        <p:nvPicPr>
          <p:cNvPr id="7" name="Picture 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36" t="42010" r="36939" b="43880"/>
          <a:stretch/>
        </p:blipFill>
        <p:spPr>
          <a:xfrm>
            <a:off x="1163016" y="5919202"/>
            <a:ext cx="2160000" cy="14400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702014" y="2085434"/>
            <a:ext cx="1082003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/>
          <p:cNvSpPr/>
          <p:nvPr/>
        </p:nvSpPr>
        <p:spPr>
          <a:xfrm>
            <a:off x="1702014" y="3023719"/>
            <a:ext cx="1082003" cy="376626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/>
          <p:cNvSpPr/>
          <p:nvPr/>
        </p:nvSpPr>
        <p:spPr>
          <a:xfrm>
            <a:off x="1625810" y="6528207"/>
            <a:ext cx="1083600" cy="378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1715537" y="4529911"/>
            <a:ext cx="1083600" cy="360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3745288" y="2124527"/>
            <a:ext cx="1083600" cy="378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6" name="Picture 15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99" t="36134" r="41557" b="36612"/>
          <a:stretch/>
        </p:blipFill>
        <p:spPr>
          <a:xfrm>
            <a:off x="3739012" y="3702457"/>
            <a:ext cx="2160000" cy="2159999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3821490" y="4521649"/>
            <a:ext cx="1083600" cy="360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8" name="Picture 1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07" t="41047" r="27287" b="43396"/>
          <a:stretch/>
        </p:blipFill>
        <p:spPr>
          <a:xfrm>
            <a:off x="3755388" y="5967662"/>
            <a:ext cx="2160000" cy="139154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3745512" y="6524788"/>
            <a:ext cx="1083600" cy="420067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TextBox 27"/>
          <p:cNvSpPr txBox="1"/>
          <p:nvPr/>
        </p:nvSpPr>
        <p:spPr>
          <a:xfrm>
            <a:off x="332486" y="2008190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GLI3F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4324" y="3098744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GLI3R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76767" y="4495211"/>
            <a:ext cx="975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3745288" y="3106720"/>
            <a:ext cx="1083600" cy="378000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3" name="Straight Connector 32"/>
          <p:cNvCxnSpPr/>
          <p:nvPr/>
        </p:nvCxnSpPr>
        <p:spPr>
          <a:xfrm>
            <a:off x="1666890" y="1656340"/>
            <a:ext cx="108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708431" y="1668895"/>
            <a:ext cx="482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81469" y="1663291"/>
            <a:ext cx="380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41245" y="1348089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EFs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3798607" y="1655038"/>
            <a:ext cx="1080000" cy="1310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840148" y="1667593"/>
            <a:ext cx="4828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413186" y="1661989"/>
            <a:ext cx="380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849124" y="831122"/>
            <a:ext cx="94769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Kidney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37475" y="2074548"/>
            <a:ext cx="44675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3620605" y="2188701"/>
            <a:ext cx="105071" cy="1121232"/>
            <a:chOff x="3140143" y="2547256"/>
            <a:chExt cx="105071" cy="1121232"/>
          </a:xfrm>
        </p:grpSpPr>
        <p:cxnSp>
          <p:nvCxnSpPr>
            <p:cNvPr id="44" name="Straight Connector 43"/>
            <p:cNvCxnSpPr/>
            <p:nvPr/>
          </p:nvCxnSpPr>
          <p:spPr>
            <a:xfrm>
              <a:off x="3140143" y="366848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3140143" y="334190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140143" y="2993570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TextBox 49"/>
          <p:cNvSpPr txBox="1"/>
          <p:nvPr/>
        </p:nvSpPr>
        <p:spPr>
          <a:xfrm>
            <a:off x="3376273" y="3746246"/>
            <a:ext cx="420371" cy="17851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r"/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3308069" y="3851481"/>
            <a:ext cx="105071" cy="1175662"/>
            <a:chOff x="3140143" y="2547256"/>
            <a:chExt cx="105071" cy="1175662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3140143" y="372291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3140143" y="339633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3140143" y="2873828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3140143" y="2743204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3140143" y="2547256"/>
              <a:ext cx="105071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8" name="Straight Connector 57"/>
          <p:cNvCxnSpPr/>
          <p:nvPr/>
        </p:nvCxnSpPr>
        <p:spPr>
          <a:xfrm>
            <a:off x="3308066" y="5397259"/>
            <a:ext cx="105071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3340724" y="5911986"/>
            <a:ext cx="341825" cy="14619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91464" y="205869"/>
            <a:ext cx="3563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Figure 5 D (Middle and Right panel)</a:t>
            </a:r>
            <a:endParaRPr lang="en-GB" b="1" dirty="0">
              <a:solidFill>
                <a:srgbClr val="0070C0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37577" y="6524788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0192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77</TotalTime>
  <Words>237</Words>
  <Application>Microsoft Office PowerPoint</Application>
  <PresentationFormat>A4 Paper (210x297 mm)</PresentationFormat>
  <Paragraphs>16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St Georges, University of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o-Hyun Kim</dc:creator>
  <cp:lastModifiedBy>Soo-Hyun Kim</cp:lastModifiedBy>
  <cp:revision>166</cp:revision>
  <dcterms:created xsi:type="dcterms:W3CDTF">2016-08-15T10:56:31Z</dcterms:created>
  <dcterms:modified xsi:type="dcterms:W3CDTF">2017-11-13T18:23:14Z</dcterms:modified>
</cp:coreProperties>
</file>